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8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1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E26E5D-320F-4D04-99EF-6F11DFFEFB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7E9950A-FFD4-4730-A33D-609D9AF984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8006A9-415A-40EC-8135-8768E9FEA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6969-B790-4047-8EDC-8BA29EE84962}" type="datetimeFigureOut">
              <a:rPr lang="en-AU" smtClean="0"/>
              <a:t>16/10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E52760-99B8-4B8F-98F6-514B56BCA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68F7FE-69E0-4673-8F1D-8466FE3D3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B8067-1873-426D-9A7E-97BCC62945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819994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2913B5-D7AC-4763-99D3-4F0EF1E211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1DA0A0-A5D5-4DCF-90BF-B018C4EE31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FEBC9A-CADD-4C32-9776-71B21AE99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6969-B790-4047-8EDC-8BA29EE84962}" type="datetimeFigureOut">
              <a:rPr lang="en-AU" smtClean="0"/>
              <a:t>16/10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F5BEC6-AE61-4CAE-9A20-9411A096B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6F0170-9556-4127-B2C4-31571642A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B8067-1873-426D-9A7E-97BCC62945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5205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9B4BC8-3475-4F4D-9348-BDD67D10BB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73F4EC6-028C-4CF4-B70F-460E2DFE42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A9B42E-91EB-4EB1-AAFA-601E78D996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6969-B790-4047-8EDC-8BA29EE84962}" type="datetimeFigureOut">
              <a:rPr lang="en-AU" smtClean="0"/>
              <a:t>16/10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CA7131-A079-4EB4-8675-EBE8C86CC1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57B2EE-4FA7-4A50-AE41-AC9D3FC12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B8067-1873-426D-9A7E-97BCC62945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59663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87F5F-2FD2-415C-8E21-4546C5DF94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B23862-795B-451F-B32E-D6F306B1EF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4F93F9-4DF0-4555-B2C6-B517773FF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6969-B790-4047-8EDC-8BA29EE84962}" type="datetimeFigureOut">
              <a:rPr lang="en-AU" smtClean="0"/>
              <a:t>16/10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9B0D57-8B43-44D9-9767-6479096F13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1EA683-48A5-402C-9F9F-14FE1EB90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B8067-1873-426D-9A7E-97BCC62945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56359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18BC87-245B-4CFD-83CC-7C2EE7615F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0D1354-952E-4FA2-9D97-36226A1DC5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231B2B-7389-4D89-86CB-750D2B5C6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6969-B790-4047-8EDC-8BA29EE84962}" type="datetimeFigureOut">
              <a:rPr lang="en-AU" smtClean="0"/>
              <a:t>16/10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6D52FF-6A2E-4036-A126-2814F0085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7B0F2C-CC03-40DB-9F55-12A1E98C1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B8067-1873-426D-9A7E-97BCC62945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54812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7CB0E9-27D2-4428-8733-0AACF05809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79E90F-5D71-46DD-8C88-0048211AC9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AB83FF-DAF1-4AE0-9B6E-CD91CE8385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317062-2BA9-4C50-A505-6136B83C9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6969-B790-4047-8EDC-8BA29EE84962}" type="datetimeFigureOut">
              <a:rPr lang="en-AU" smtClean="0"/>
              <a:t>16/10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98283C-7065-4773-A0CC-54B116FAF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3AEA2B-6F83-4267-B221-1E0A7D08AB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B8067-1873-426D-9A7E-97BCC62945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53631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7AE0FD-D4FA-4563-A400-3609C8BCA0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4A17FA-1D14-4072-B923-32FA28A220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998444-6332-4F2C-A959-43F8612112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EA70EAF-158B-4A01-8272-51C5276FE0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D649AF-EE8E-4E28-8C8D-1459D19609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ECF36AB-666E-4263-AF1A-72ECAED216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6969-B790-4047-8EDC-8BA29EE84962}" type="datetimeFigureOut">
              <a:rPr lang="en-AU" smtClean="0"/>
              <a:t>16/10/2020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B0C2AA-219F-44EF-972C-422C52930B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35BC94E-2979-41C8-AF89-754179E4A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B8067-1873-426D-9A7E-97BCC62945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7767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FF713-F483-4F5E-BE53-CEA80E9D33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47FE47-4207-409F-9425-B25BB95222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6969-B790-4047-8EDC-8BA29EE84962}" type="datetimeFigureOut">
              <a:rPr lang="en-AU" smtClean="0"/>
              <a:t>16/10/2020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2F6BE07-7A92-4BB7-871E-F1F534F255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9C2EE70-A421-40D6-9361-730775D02C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B8067-1873-426D-9A7E-97BCC62945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33349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9D809C-35CB-456A-8A1D-7527088C74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6969-B790-4047-8EDC-8BA29EE84962}" type="datetimeFigureOut">
              <a:rPr lang="en-AU" smtClean="0"/>
              <a:t>16/10/2020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20D62C-F3F2-4E9C-A7E2-E13C1B84AC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8B7D20D-D802-44C4-9EBA-59D822B87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B8067-1873-426D-9A7E-97BCC62945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47239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AD5DD-8959-4B8D-A9D9-FAF3214D92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68B3CB-1E0A-4F5D-98BE-4FF34143C4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AB24B1-03FA-4D29-B579-C796267545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ED92F2-F136-4AAF-BA98-5F3094E21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6969-B790-4047-8EDC-8BA29EE84962}" type="datetimeFigureOut">
              <a:rPr lang="en-AU" smtClean="0"/>
              <a:t>16/10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72A91E-D51B-40F4-8395-E2D4447E8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D68DFD-E735-42E2-B8A5-BD82ABB03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B8067-1873-426D-9A7E-97BCC62945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19882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059403-974D-477A-A2C4-D8E0EBD468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4678DD9-089F-4246-BA9B-810F519094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020D08-E2AE-45DB-8030-D6726C2388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44995D-79A7-4FCD-9525-3B8D877C78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36969-B790-4047-8EDC-8BA29EE84962}" type="datetimeFigureOut">
              <a:rPr lang="en-AU" smtClean="0"/>
              <a:t>16/10/2020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321BC3-C843-4754-92AB-881668127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34096B-2702-4E37-A349-C091F6287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B8067-1873-426D-9A7E-97BCC62945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02482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F7454D8-67F0-4E7F-8F72-F81FA28C76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6ED239-2681-448E-9C7B-6278866D43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5C81FA-CA2E-4E5F-B428-857D5D34ED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536969-B790-4047-8EDC-8BA29EE84962}" type="datetimeFigureOut">
              <a:rPr lang="en-AU" smtClean="0"/>
              <a:t>16/10/2020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DD4C04-60F7-47A2-96CD-6C9AEB36A8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A6C7E7-6DFF-4E7E-AA1D-CAB2F8DF8A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B8067-1873-426D-9A7E-97BCC629450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5147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A2AB4E3A-91CE-403A-8638-9894A59DCBD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67" r="-1"/>
          <a:stretch/>
        </p:blipFill>
        <p:spPr>
          <a:xfrm>
            <a:off x="533400" y="367608"/>
            <a:ext cx="10448278" cy="435133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BE495AE-98C9-384B-9C14-95D1CB98FC2F}"/>
              </a:ext>
            </a:extLst>
          </p:cNvPr>
          <p:cNvSpPr txBox="1"/>
          <p:nvPr/>
        </p:nvSpPr>
        <p:spPr>
          <a:xfrm>
            <a:off x="1823721" y="186716"/>
            <a:ext cx="73012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i="1" dirty="0" smtClean="0"/>
              <a:t>t</a:t>
            </a:r>
            <a:r>
              <a:rPr lang="en-US" altLang="zh-CN" sz="1400" b="1" dirty="0" smtClean="0"/>
              <a:t>Zeatin</a:t>
            </a:r>
            <a:endParaRPr lang="en-US" sz="14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1D0553A-90CB-184A-8CEA-E625856C85E3}"/>
              </a:ext>
            </a:extLst>
          </p:cNvPr>
          <p:cNvSpPr txBox="1"/>
          <p:nvPr/>
        </p:nvSpPr>
        <p:spPr>
          <a:xfrm>
            <a:off x="2302603" y="186716"/>
            <a:ext cx="76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/>
              <a:t>DHZ</a:t>
            </a:r>
            <a:endParaRPr lang="en-US" sz="14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549E823-7491-A045-BD4C-0D83C45B6D40}"/>
              </a:ext>
            </a:extLst>
          </p:cNvPr>
          <p:cNvSpPr txBox="1"/>
          <p:nvPr/>
        </p:nvSpPr>
        <p:spPr>
          <a:xfrm>
            <a:off x="3044158" y="186716"/>
            <a:ext cx="76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i="1" dirty="0"/>
              <a:t>t</a:t>
            </a:r>
            <a:r>
              <a:rPr lang="en-US" altLang="zh-CN" sz="1400" b="1" dirty="0"/>
              <a:t>ZR</a:t>
            </a:r>
            <a:endParaRPr lang="en-US" sz="14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764E2F8-8BAE-F142-809E-F5CB3EED7467}"/>
              </a:ext>
            </a:extLst>
          </p:cNvPr>
          <p:cNvSpPr txBox="1"/>
          <p:nvPr/>
        </p:nvSpPr>
        <p:spPr>
          <a:xfrm>
            <a:off x="3583904" y="186716"/>
            <a:ext cx="61962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/>
              <a:t>DHZR</a:t>
            </a:r>
            <a:endParaRPr lang="en-US" sz="14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41E7AA9-EF51-3847-8C14-9FE3BF92F1DC}"/>
              </a:ext>
            </a:extLst>
          </p:cNvPr>
          <p:cNvSpPr txBox="1"/>
          <p:nvPr/>
        </p:nvSpPr>
        <p:spPr>
          <a:xfrm>
            <a:off x="4036963" y="186715"/>
            <a:ext cx="76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/>
              <a:t>iPAMP</a:t>
            </a:r>
            <a:endParaRPr lang="en-US" sz="14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B1C30E9-8CFA-3A4B-9397-A5B878CE089C}"/>
              </a:ext>
            </a:extLst>
          </p:cNvPr>
          <p:cNvSpPr txBox="1"/>
          <p:nvPr/>
        </p:nvSpPr>
        <p:spPr>
          <a:xfrm>
            <a:off x="5811378" y="186714"/>
            <a:ext cx="5494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/>
              <a:t>iP</a:t>
            </a:r>
            <a:endParaRPr lang="en-US" sz="14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AD9AE62-258C-F047-94A2-CD52373512D3}"/>
              </a:ext>
            </a:extLst>
          </p:cNvPr>
          <p:cNvSpPr txBox="1"/>
          <p:nvPr/>
        </p:nvSpPr>
        <p:spPr>
          <a:xfrm>
            <a:off x="7418450" y="186713"/>
            <a:ext cx="5494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/>
              <a:t>iPA</a:t>
            </a:r>
            <a:endParaRPr lang="en-US" sz="14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18B003-C0ED-7E47-9DA8-05FD86367B19}"/>
              </a:ext>
            </a:extLst>
          </p:cNvPr>
          <p:cNvSpPr txBox="1"/>
          <p:nvPr/>
        </p:nvSpPr>
        <p:spPr>
          <a:xfrm>
            <a:off x="9036934" y="186713"/>
            <a:ext cx="5494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/>
              <a:t>IAA</a:t>
            </a:r>
            <a:endParaRPr lang="en-US" sz="1400" b="1" baseline="-25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D7EB4B5-2957-C74B-BFA3-C6C39C429BB3}"/>
              </a:ext>
            </a:extLst>
          </p:cNvPr>
          <p:cNvSpPr txBox="1"/>
          <p:nvPr/>
        </p:nvSpPr>
        <p:spPr>
          <a:xfrm>
            <a:off x="10295536" y="186713"/>
            <a:ext cx="5494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/>
              <a:t>ABA</a:t>
            </a:r>
            <a:endParaRPr lang="en-US" sz="1400" b="1" baseline="-25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AEB48D0-3F32-E14C-93BB-1B1BFB29D4EF}"/>
              </a:ext>
            </a:extLst>
          </p:cNvPr>
          <p:cNvSpPr txBox="1"/>
          <p:nvPr/>
        </p:nvSpPr>
        <p:spPr>
          <a:xfrm>
            <a:off x="10710643" y="186713"/>
            <a:ext cx="5494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/>
              <a:t>GA</a:t>
            </a:r>
            <a:r>
              <a:rPr lang="en-US" altLang="zh-CN" sz="1400" b="1" baseline="-25000" dirty="0"/>
              <a:t>20</a:t>
            </a:r>
            <a:endParaRPr lang="en-US" sz="1400" b="1" baseline="-250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CE509C4-C001-7F4F-981E-788069747652}"/>
              </a:ext>
            </a:extLst>
          </p:cNvPr>
          <p:cNvSpPr txBox="1"/>
          <p:nvPr/>
        </p:nvSpPr>
        <p:spPr>
          <a:xfrm>
            <a:off x="4983034" y="186715"/>
            <a:ext cx="76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GA</a:t>
            </a:r>
            <a:r>
              <a:rPr lang="en-US" sz="1400" b="1" baseline="-25000" dirty="0"/>
              <a:t>29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CE509C4-C001-7F4F-981E-788069747652}"/>
              </a:ext>
            </a:extLst>
          </p:cNvPr>
          <p:cNvSpPr txBox="1"/>
          <p:nvPr/>
        </p:nvSpPr>
        <p:spPr>
          <a:xfrm>
            <a:off x="8354105" y="186713"/>
            <a:ext cx="76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GA</a:t>
            </a:r>
            <a:r>
              <a:rPr lang="en-US" sz="1400" b="1" baseline="-25000" dirty="0"/>
              <a:t>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75229C0-97DB-9040-BCA5-0C5482C7F3F9}"/>
              </a:ext>
            </a:extLst>
          </p:cNvPr>
          <p:cNvSpPr txBox="1"/>
          <p:nvPr/>
        </p:nvSpPr>
        <p:spPr>
          <a:xfrm>
            <a:off x="1234875" y="186716"/>
            <a:ext cx="7748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i="1" dirty="0"/>
              <a:t>t</a:t>
            </a:r>
            <a:r>
              <a:rPr lang="en-US" altLang="zh-CN" sz="1400" b="1" dirty="0"/>
              <a:t>ZMP</a:t>
            </a:r>
            <a:endParaRPr 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64789" y="4802073"/>
            <a:ext cx="1154759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ry figure 4</a:t>
            </a:r>
            <a:r>
              <a:rPr lang="en-US" dirty="0" smtClean="0"/>
              <a:t>. LC-MS </a:t>
            </a:r>
            <a:r>
              <a:rPr lang="en-US" dirty="0"/>
              <a:t>chromatogram showing the separation of 13 </a:t>
            </a:r>
            <a:r>
              <a:rPr lang="en-US" dirty="0" smtClean="0"/>
              <a:t>phytohormones </a:t>
            </a:r>
            <a:r>
              <a:rPr lang="en-US" altLang="zh-CN" dirty="0" smtClean="0"/>
              <a:t>from pea axillary </a:t>
            </a:r>
            <a:r>
              <a:rPr lang="en-US" altLang="zh-CN" dirty="0" smtClean="0"/>
              <a:t>buds. The intensity has been presented as 100% for each hormone to show them in one graph.</a:t>
            </a:r>
            <a:endParaRPr lang="en-US" altLang="zh-CN" dirty="0" smtClean="0"/>
          </a:p>
          <a:p>
            <a:r>
              <a:rPr lang="en-US" dirty="0" smtClean="0"/>
              <a:t>Abbreviations</a:t>
            </a:r>
            <a:r>
              <a:rPr lang="en-US" dirty="0"/>
              <a:t>: </a:t>
            </a:r>
            <a:r>
              <a:rPr lang="en-US" i="1" dirty="0" err="1"/>
              <a:t>t</a:t>
            </a:r>
            <a:r>
              <a:rPr lang="en-US" dirty="0" err="1"/>
              <a:t>Zeatin</a:t>
            </a:r>
            <a:r>
              <a:rPr lang="en-US" dirty="0"/>
              <a:t>, </a:t>
            </a:r>
            <a:r>
              <a:rPr lang="en-US" i="1" dirty="0"/>
              <a:t>trans</a:t>
            </a:r>
            <a:r>
              <a:rPr lang="en-US" dirty="0"/>
              <a:t>-</a:t>
            </a:r>
            <a:r>
              <a:rPr lang="en-US" dirty="0" err="1"/>
              <a:t>zeatin</a:t>
            </a:r>
            <a:r>
              <a:rPr lang="en-US" dirty="0"/>
              <a:t>; </a:t>
            </a:r>
            <a:r>
              <a:rPr lang="en-US" i="1" dirty="0" err="1"/>
              <a:t>t</a:t>
            </a:r>
            <a:r>
              <a:rPr lang="en-US" dirty="0" err="1"/>
              <a:t>ZMP</a:t>
            </a:r>
            <a:r>
              <a:rPr lang="en-US" dirty="0"/>
              <a:t>, </a:t>
            </a:r>
            <a:r>
              <a:rPr lang="en-US" i="1" dirty="0"/>
              <a:t>trans</a:t>
            </a:r>
            <a:r>
              <a:rPr lang="en-US" dirty="0"/>
              <a:t>-</a:t>
            </a:r>
            <a:r>
              <a:rPr lang="en-US" dirty="0" err="1"/>
              <a:t>zeatin</a:t>
            </a:r>
            <a:r>
              <a:rPr lang="en-US" dirty="0"/>
              <a:t> riboside-5'-monophosphate; DHZ, </a:t>
            </a:r>
            <a:r>
              <a:rPr lang="en-US" dirty="0" err="1"/>
              <a:t>dihydrozeatin</a:t>
            </a:r>
            <a:r>
              <a:rPr lang="en-US" dirty="0"/>
              <a:t>; </a:t>
            </a:r>
            <a:r>
              <a:rPr lang="en-US" i="1" dirty="0" err="1"/>
              <a:t>t</a:t>
            </a:r>
            <a:r>
              <a:rPr lang="en-US" dirty="0" err="1"/>
              <a:t>ZR</a:t>
            </a:r>
            <a:r>
              <a:rPr lang="en-US" dirty="0"/>
              <a:t>, </a:t>
            </a:r>
            <a:r>
              <a:rPr lang="en-US" i="1" dirty="0"/>
              <a:t>trans</a:t>
            </a:r>
            <a:r>
              <a:rPr lang="en-US" dirty="0"/>
              <a:t>-</a:t>
            </a:r>
            <a:r>
              <a:rPr lang="en-US" dirty="0" err="1"/>
              <a:t>zeatin</a:t>
            </a:r>
            <a:r>
              <a:rPr lang="en-US" dirty="0"/>
              <a:t> riboside; DHZR, </a:t>
            </a:r>
            <a:r>
              <a:rPr lang="en-US" dirty="0" err="1"/>
              <a:t>dihydrozeatin</a:t>
            </a:r>
            <a:r>
              <a:rPr lang="en-US" dirty="0"/>
              <a:t> </a:t>
            </a:r>
            <a:r>
              <a:rPr lang="en-US" dirty="0" err="1"/>
              <a:t>ribodide</a:t>
            </a:r>
            <a:r>
              <a:rPr lang="en-US" dirty="0"/>
              <a:t>; </a:t>
            </a:r>
            <a:r>
              <a:rPr lang="en-US" dirty="0" err="1"/>
              <a:t>iPAMP</a:t>
            </a:r>
            <a:r>
              <a:rPr lang="en-US" dirty="0"/>
              <a:t>, isopentenyladenosine-5'-Monophosphate; </a:t>
            </a:r>
            <a:r>
              <a:rPr lang="en-US" dirty="0" err="1"/>
              <a:t>iP</a:t>
            </a:r>
            <a:r>
              <a:rPr lang="en-US" dirty="0"/>
              <a:t>, </a:t>
            </a:r>
            <a:r>
              <a:rPr lang="en-US" dirty="0" err="1"/>
              <a:t>isopentenyladenine</a:t>
            </a:r>
            <a:r>
              <a:rPr lang="en-US" dirty="0"/>
              <a:t>; </a:t>
            </a:r>
            <a:r>
              <a:rPr lang="en-US" dirty="0" err="1"/>
              <a:t>iPA</a:t>
            </a:r>
            <a:r>
              <a:rPr lang="en-US" dirty="0"/>
              <a:t>, </a:t>
            </a:r>
            <a:r>
              <a:rPr lang="en-US" dirty="0" err="1"/>
              <a:t>isopentenyladenosine</a:t>
            </a:r>
            <a:r>
              <a:rPr lang="en-US" dirty="0"/>
              <a:t>;  ABA, </a:t>
            </a:r>
            <a:r>
              <a:rPr lang="en-US" dirty="0" err="1"/>
              <a:t>abscisic</a:t>
            </a:r>
            <a:r>
              <a:rPr lang="en-US" dirty="0"/>
              <a:t> acid; GA</a:t>
            </a:r>
            <a:r>
              <a:rPr lang="en-US" sz="1050" dirty="0"/>
              <a:t>1</a:t>
            </a:r>
            <a:r>
              <a:rPr lang="en-US" dirty="0"/>
              <a:t>, </a:t>
            </a:r>
            <a:r>
              <a:rPr lang="en-US" sz="1050" dirty="0"/>
              <a:t>20</a:t>
            </a:r>
            <a:r>
              <a:rPr lang="en-US" dirty="0"/>
              <a:t> and </a:t>
            </a:r>
            <a:r>
              <a:rPr lang="en-US" sz="1050" dirty="0"/>
              <a:t>29</a:t>
            </a:r>
            <a:r>
              <a:rPr lang="en-US" dirty="0"/>
              <a:t>, gibberellin A</a:t>
            </a:r>
            <a:r>
              <a:rPr lang="en-US" sz="1050" dirty="0"/>
              <a:t>1</a:t>
            </a:r>
            <a:r>
              <a:rPr lang="en-US" dirty="0"/>
              <a:t>, A</a:t>
            </a:r>
            <a:r>
              <a:rPr lang="en-US" sz="1050" dirty="0"/>
              <a:t>20</a:t>
            </a:r>
            <a:r>
              <a:rPr lang="en-US" dirty="0"/>
              <a:t> and A</a:t>
            </a:r>
            <a:r>
              <a:rPr lang="en-US" sz="1050" dirty="0"/>
              <a:t>29</a:t>
            </a:r>
            <a:r>
              <a:rPr lang="en-US" dirty="0"/>
              <a:t>; IAA, indole-3-acetic acid.</a:t>
            </a:r>
          </a:p>
          <a:p>
            <a:endParaRPr lang="en-AU" i="1" dirty="0"/>
          </a:p>
        </p:txBody>
      </p:sp>
    </p:spTree>
    <p:extLst>
      <p:ext uri="{BB962C8B-B14F-4D97-AF65-F5344CB8AC3E}">
        <p14:creationId xmlns:p14="http://schemas.microsoft.com/office/powerpoint/2010/main" val="2198575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12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DengXian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anda Nouwens</dc:creator>
  <cp:lastModifiedBy>Da Cao</cp:lastModifiedBy>
  <cp:revision>11</cp:revision>
  <dcterms:created xsi:type="dcterms:W3CDTF">2020-10-16T01:56:15Z</dcterms:created>
  <dcterms:modified xsi:type="dcterms:W3CDTF">2020-10-16T03:10:59Z</dcterms:modified>
</cp:coreProperties>
</file>